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58" r:id="rId4"/>
    <p:sldId id="259" r:id="rId5"/>
    <p:sldId id="260" r:id="rId6"/>
    <p:sldId id="262" r:id="rId7"/>
    <p:sldId id="261" r:id="rId8"/>
    <p:sldId id="265" r:id="rId9"/>
    <p:sldId id="266" r:id="rId10"/>
    <p:sldId id="267" r:id="rId11"/>
    <p:sldId id="268" r:id="rId12"/>
    <p:sldId id="269" r:id="rId13"/>
    <p:sldId id="257" r:id="rId14"/>
    <p:sldId id="270" r:id="rId15"/>
    <p:sldId id="271" r:id="rId16"/>
    <p:sldId id="264" r:id="rId17"/>
    <p:sldId id="272" r:id="rId18"/>
    <p:sldId id="274" r:id="rId19"/>
    <p:sldId id="275" r:id="rId20"/>
    <p:sldId id="428" r:id="rId21"/>
    <p:sldId id="429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221" autoAdjust="0"/>
  </p:normalViewPr>
  <p:slideViewPr>
    <p:cSldViewPr snapToGrid="0">
      <p:cViewPr>
        <p:scale>
          <a:sx n="218" d="100"/>
          <a:sy n="218" d="100"/>
        </p:scale>
        <p:origin x="125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5B9EC-5DC5-4097-BDA3-470B4B278A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9B8C71-85D8-42C8-A699-0F81FCE1EB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F115C-CF58-4C19-B593-F42C794CB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EA306-75A0-431B-BA4D-EA53139FD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6D78F0-7263-48DB-8B09-3948196E3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873628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C5643-BAD4-403A-BF23-ED0EBF9D2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7F7B3B-DF9B-46F0-A511-3D570AB1D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AF88E-9D05-4E82-8AC4-2A5DAF976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5AC3BB-6498-4BDC-8C8F-6497A76B1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BBE006-C48C-4B21-A036-C15DB2000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1889872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99F452-AD47-403B-921F-535E937D0A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B8434C-925F-495B-8DA8-57ABFD3469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FE52F-FA5E-4B51-8B15-1215A78E1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10480B-5DCA-4FFF-9920-EA4BA7471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BA763-3151-4DC7-A695-991ADB469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1588223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451187-4EBA-461F-B2F3-B098EA504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C31647-47C3-4607-8060-8FD447305B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31DF26-2094-4445-9611-6DC4EC2F6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1143F4-809C-4A39-80FA-6D09BCAF0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DC092-C1EA-45BA-9562-CADB071F6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129148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9476-8C96-4711-8CF9-01840A032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B32062-28D5-4C3C-863F-E53416588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6C789-B6DE-4F65-9A2D-DD8EFC256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B96640-0B1C-4469-B97D-16464F29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4EA6D6-8FB1-49F0-B596-0592130B9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940090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2FFB7C-3FDC-4FB6-9DB2-17AC4B3860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844991-7909-4CAF-9E80-B78C2D68F3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114131-F791-47D2-BDAB-1FC455FA6E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17EC95-A30F-430B-871A-5EDDC44E8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B9FC31-1747-4639-BCB1-B35403E5E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653873-E882-4745-8565-97596444B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457747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43D03-816F-41CA-81EA-6B06A68F7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043EEF-A2F0-4C05-BC2F-BAB92023C0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B1F959-B8E1-4FC5-A5FE-9D6E652B7B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A1865E-8A62-4704-B483-F5B427BC6B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5A380F-178C-49CE-B97F-82A73FC054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4BE646-D517-4EDA-AB3B-6F5A35B81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027838-354C-4A6F-8C28-69144978C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1E87F7-86D1-4C31-9ECC-03F7CB2FD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075974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5A3C17-E1C5-4188-A3AC-D21A6A2551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40002D-85A9-4567-9664-76EF50F57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6B386B-5613-49B2-90DD-77911D3A5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FB81B5-F2D9-4F44-BFD1-59980000D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71648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E639E2-6904-411D-87C5-E1652292F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9CE52C-B689-431A-8900-2F746A5DC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253087-DAE4-4E57-A02B-2DBA456EA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186143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D0F16-33DC-42D2-A9F6-40BC76EB67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994D4F-B426-4813-9E5B-181BAF45F6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E480F9-BBB4-4C47-B8C6-B72CC99BD1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CCB534-E5B1-4294-8F08-A2362FCA4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BCA9EB-FD92-43EB-A300-FF30ED679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213999-6002-4E6C-80A2-27BCCA8E0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4027097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C1E42-11F0-4D7A-B139-6DB3FC84B2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7CFDAD-730C-4C81-B873-AFBA5166F0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H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A42D51-1381-45C8-8E28-1D3112241A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DEEE57-906F-4768-90D5-84C8963F9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B6DFD6-5EBA-46C0-B2A2-26A4D6BC4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6FE044-E3CE-4240-AD5F-E9ABC2637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1454208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8794A8-3B07-40E5-A7D6-7465B690E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86A5AE-B193-4FF1-989C-997CD7791D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035618-44AA-4F0B-B743-9D6C19FE1E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C4E2E-3991-4C76-AA4F-8300D507D65A}" type="datetimeFigureOut">
              <a:rPr lang="en-HK" smtClean="0"/>
              <a:t>14 Jul 2021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07CE9-37F1-44F6-921A-C884B93E5C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83D163-F56E-4BDB-878B-FA90496692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9EAE7-EAA1-41E6-B9D8-243864196C66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855345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013F03D-8456-48B0-8169-2E9AA8DC07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3283" y="0"/>
            <a:ext cx="3720958" cy="6858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2F6C46F-4841-4EEF-B6B4-72DF483C814E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AT</a:t>
            </a:r>
            <a:endParaRPr lang="en-HK" dirty="0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EA487B13-4F63-4DE7-A26F-FB86693197E3}"/>
              </a:ext>
            </a:extLst>
          </p:cNvPr>
          <p:cNvSpPr/>
          <p:nvPr/>
        </p:nvSpPr>
        <p:spPr>
          <a:xfrm>
            <a:off x="4902958" y="0"/>
            <a:ext cx="3177014" cy="3490934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CDB5B398-0722-43C8-8B33-0381302318C1}"/>
              </a:ext>
            </a:extLst>
          </p:cNvPr>
          <p:cNvSpPr/>
          <p:nvPr/>
        </p:nvSpPr>
        <p:spPr>
          <a:xfrm>
            <a:off x="4902959" y="3490934"/>
            <a:ext cx="3177012" cy="2824567"/>
          </a:xfrm>
          <a:prstGeom prst="roundRect">
            <a:avLst>
              <a:gd name="adj" fmla="val 5771"/>
            </a:avLst>
          </a:prstGeom>
          <a:solidFill>
            <a:srgbClr val="FFC00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1FD168-FAE7-4DA7-880B-96FDBFBF4771}"/>
              </a:ext>
            </a:extLst>
          </p:cNvPr>
          <p:cNvSpPr txBox="1"/>
          <p:nvPr/>
        </p:nvSpPr>
        <p:spPr>
          <a:xfrm>
            <a:off x="8079971" y="1560801"/>
            <a:ext cx="783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A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B677DF-73FA-4968-A8D6-A48529AD4CE7}"/>
              </a:ext>
            </a:extLst>
          </p:cNvPr>
          <p:cNvSpPr txBox="1"/>
          <p:nvPr/>
        </p:nvSpPr>
        <p:spPr>
          <a:xfrm>
            <a:off x="8081785" y="4620469"/>
            <a:ext cx="783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AT2</a:t>
            </a:r>
          </a:p>
        </p:txBody>
      </p:sp>
    </p:spTree>
    <p:extLst>
      <p:ext uri="{BB962C8B-B14F-4D97-AF65-F5344CB8AC3E}">
        <p14:creationId xmlns:p14="http://schemas.microsoft.com/office/powerpoint/2010/main" val="28176498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65C81F8-5C1D-4DF6-B595-E4C600BF66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0011" y="519002"/>
            <a:ext cx="7381631" cy="60034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928649-E3B8-4AB4-9837-C4B8145E04FE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E14/ICMT</a:t>
            </a:r>
            <a:endParaRPr lang="en-HK" dirty="0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B8A1D27F-FB72-4CA7-859B-86DBC03512B4}"/>
              </a:ext>
            </a:extLst>
          </p:cNvPr>
          <p:cNvSpPr/>
          <p:nvPr/>
        </p:nvSpPr>
        <p:spPr>
          <a:xfrm>
            <a:off x="5257800" y="519002"/>
            <a:ext cx="4323522" cy="5265571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5250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1EFC1F6-3BF8-432C-A3D6-07B219A3CE8C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CYOX1</a:t>
            </a:r>
            <a:endParaRPr lang="en-HK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71D40C6-B9C8-48DE-B876-79E364DE61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3625" y="369332"/>
            <a:ext cx="7372370" cy="6119985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6FFAEBC0-FBF8-414C-A624-4DEBEFB406C4}"/>
              </a:ext>
            </a:extLst>
          </p:cNvPr>
          <p:cNvSpPr/>
          <p:nvPr/>
        </p:nvSpPr>
        <p:spPr>
          <a:xfrm>
            <a:off x="3965711" y="368683"/>
            <a:ext cx="5923726" cy="5336378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70020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8F8DF17-4C16-46BA-98F1-296F2EF5E3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4619" y="0"/>
            <a:ext cx="5722762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30D078E-28EE-4BD0-990A-DE3CE1B00814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DFT/SQS</a:t>
            </a:r>
            <a:endParaRPr lang="en-HK" dirty="0"/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F839EDCE-52C6-403D-AAA7-09CEC008163B}"/>
              </a:ext>
            </a:extLst>
          </p:cNvPr>
          <p:cNvSpPr/>
          <p:nvPr/>
        </p:nvSpPr>
        <p:spPr>
          <a:xfrm>
            <a:off x="4984845" y="59635"/>
            <a:ext cx="4252462" cy="5939340"/>
          </a:xfrm>
          <a:prstGeom prst="roundRect">
            <a:avLst>
              <a:gd name="adj" fmla="val 4747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6618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61B4F13-EDE4-4BB1-B364-9BD7479EC3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7775" y="0"/>
            <a:ext cx="9236449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5B04C05-C178-4AE9-BCF6-F0C77DA966A1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QLE</a:t>
            </a:r>
            <a:endParaRPr lang="en-HK" dirty="0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D1B0DFA7-C285-4D80-A71B-5D9B17E7A003}"/>
              </a:ext>
            </a:extLst>
          </p:cNvPr>
          <p:cNvSpPr/>
          <p:nvPr/>
        </p:nvSpPr>
        <p:spPr>
          <a:xfrm>
            <a:off x="3554963" y="69574"/>
            <a:ext cx="7417837" cy="5510131"/>
          </a:xfrm>
          <a:prstGeom prst="roundRect">
            <a:avLst>
              <a:gd name="adj" fmla="val 1772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1624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F8F8C56-0684-40BE-84BB-D05B2EEF04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6281" y="0"/>
            <a:ext cx="8539438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SS</a:t>
            </a:r>
            <a:endParaRPr lang="en-HK" dirty="0"/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3B1B8150-EF2B-4D10-B829-2D32700C69CE}"/>
              </a:ext>
            </a:extLst>
          </p:cNvPr>
          <p:cNvSpPr/>
          <p:nvPr/>
        </p:nvSpPr>
        <p:spPr>
          <a:xfrm>
            <a:off x="4559206" y="76487"/>
            <a:ext cx="6170997" cy="5400581"/>
          </a:xfrm>
          <a:prstGeom prst="roundRect">
            <a:avLst>
              <a:gd name="adj" fmla="val 1944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8247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6D6B5FA-8288-4040-9184-81C345622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0751" y="0"/>
            <a:ext cx="5750497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/>
              <a:t>CYP51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14BB257B-BEB3-426C-95D1-B1AC8CE682D5}"/>
              </a:ext>
            </a:extLst>
          </p:cNvPr>
          <p:cNvSpPr/>
          <p:nvPr/>
        </p:nvSpPr>
        <p:spPr>
          <a:xfrm>
            <a:off x="4581331" y="0"/>
            <a:ext cx="4758612" cy="4525347"/>
          </a:xfrm>
          <a:prstGeom prst="roundRect">
            <a:avLst>
              <a:gd name="adj" fmla="val 3489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8276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B63465BE-B134-4605-9575-540C6BE4DB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1352" y="-11174"/>
            <a:ext cx="1846855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/>
              <a:t>TM7SF2, LBR, DHCR24, DHCR7</a:t>
            </a:r>
            <a:endParaRPr lang="en-HK" dirty="0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928F8E61-ED93-4582-A1AB-36437FA8EC1C}"/>
              </a:ext>
            </a:extLst>
          </p:cNvPr>
          <p:cNvSpPr/>
          <p:nvPr/>
        </p:nvSpPr>
        <p:spPr>
          <a:xfrm>
            <a:off x="4457700" y="11174"/>
            <a:ext cx="1747158" cy="2994916"/>
          </a:xfrm>
          <a:prstGeom prst="roundRect">
            <a:avLst>
              <a:gd name="adj" fmla="val 5274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12897368-F6A7-4E80-A06F-51F918BBD935}"/>
              </a:ext>
            </a:extLst>
          </p:cNvPr>
          <p:cNvSpPr/>
          <p:nvPr/>
        </p:nvSpPr>
        <p:spPr>
          <a:xfrm>
            <a:off x="4431030" y="3006090"/>
            <a:ext cx="1773827" cy="1960245"/>
          </a:xfrm>
          <a:prstGeom prst="roundRect">
            <a:avLst>
              <a:gd name="adj" fmla="val 9848"/>
            </a:avLst>
          </a:prstGeom>
          <a:solidFill>
            <a:srgbClr val="FFC00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1CF13D71-9FF2-4EF9-8747-6921A2C05662}"/>
              </a:ext>
            </a:extLst>
          </p:cNvPr>
          <p:cNvSpPr/>
          <p:nvPr/>
        </p:nvSpPr>
        <p:spPr>
          <a:xfrm>
            <a:off x="4431029" y="4966334"/>
            <a:ext cx="1773826" cy="1777365"/>
          </a:xfrm>
          <a:prstGeom prst="roundRect">
            <a:avLst>
              <a:gd name="adj" fmla="val 10004"/>
            </a:avLst>
          </a:prstGeom>
          <a:solidFill>
            <a:srgbClr val="92D05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7381898-7583-4261-B9D8-989F15E922AA}"/>
              </a:ext>
            </a:extLst>
          </p:cNvPr>
          <p:cNvSpPr txBox="1"/>
          <p:nvPr/>
        </p:nvSpPr>
        <p:spPr>
          <a:xfrm>
            <a:off x="6219284" y="3749784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M7SF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1D9628E-7A49-4C1F-8844-4410425CF38B}"/>
              </a:ext>
            </a:extLst>
          </p:cNvPr>
          <p:cNvSpPr txBox="1"/>
          <p:nvPr/>
        </p:nvSpPr>
        <p:spPr>
          <a:xfrm>
            <a:off x="6204858" y="1005901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HCR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1585CD-EA67-4231-B368-688E798C6FD4}"/>
              </a:ext>
            </a:extLst>
          </p:cNvPr>
          <p:cNvSpPr txBox="1"/>
          <p:nvPr/>
        </p:nvSpPr>
        <p:spPr>
          <a:xfrm>
            <a:off x="6204858" y="5852099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HCR24</a:t>
            </a:r>
          </a:p>
        </p:txBody>
      </p:sp>
    </p:spTree>
    <p:extLst>
      <p:ext uri="{BB962C8B-B14F-4D97-AF65-F5344CB8AC3E}">
        <p14:creationId xmlns:p14="http://schemas.microsoft.com/office/powerpoint/2010/main" val="33158465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DD459DB-FE41-4900-92FF-F8C7FB9A02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0834" y="0"/>
            <a:ext cx="377033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/>
              <a:t>MSMO1, SC5DL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27F7C61F-3A69-4D05-915A-725826B1CF28}"/>
              </a:ext>
            </a:extLst>
          </p:cNvPr>
          <p:cNvSpPr/>
          <p:nvPr/>
        </p:nvSpPr>
        <p:spPr>
          <a:xfrm>
            <a:off x="5121081" y="-1"/>
            <a:ext cx="3018920" cy="2381133"/>
          </a:xfrm>
          <a:prstGeom prst="roundRect">
            <a:avLst>
              <a:gd name="adj" fmla="val 6862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1A75CFEF-2DA7-465E-AB12-902F0F0ACAB3}"/>
              </a:ext>
            </a:extLst>
          </p:cNvPr>
          <p:cNvSpPr/>
          <p:nvPr/>
        </p:nvSpPr>
        <p:spPr>
          <a:xfrm>
            <a:off x="5121081" y="2381133"/>
            <a:ext cx="3018921" cy="3788019"/>
          </a:xfrm>
          <a:prstGeom prst="roundRect">
            <a:avLst>
              <a:gd name="adj" fmla="val 6356"/>
            </a:avLst>
          </a:prstGeom>
          <a:solidFill>
            <a:srgbClr val="FFC00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59E6E8-216F-45A8-9B23-A65365366D6F}"/>
              </a:ext>
            </a:extLst>
          </p:cNvPr>
          <p:cNvSpPr txBox="1"/>
          <p:nvPr/>
        </p:nvSpPr>
        <p:spPr>
          <a:xfrm>
            <a:off x="8140001" y="1005899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MO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0FDA1C-2C33-4976-BD60-EC41B9F2BA9B}"/>
              </a:ext>
            </a:extLst>
          </p:cNvPr>
          <p:cNvSpPr txBox="1"/>
          <p:nvPr/>
        </p:nvSpPr>
        <p:spPr>
          <a:xfrm>
            <a:off x="8140001" y="4081370"/>
            <a:ext cx="771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5DL</a:t>
            </a:r>
          </a:p>
        </p:txBody>
      </p:sp>
    </p:spTree>
    <p:extLst>
      <p:ext uri="{BB962C8B-B14F-4D97-AF65-F5344CB8AC3E}">
        <p14:creationId xmlns:p14="http://schemas.microsoft.com/office/powerpoint/2010/main" val="255983472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E4EB4635-80AF-4A0E-A46B-D6422B3C63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45943" y="0"/>
            <a:ext cx="2900114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/>
              <a:t>NSDHL, HSD17B7</a:t>
            </a: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6FB4A47A-A42D-4292-A3F8-F5E9E3BEF52A}"/>
              </a:ext>
            </a:extLst>
          </p:cNvPr>
          <p:cNvSpPr/>
          <p:nvPr/>
        </p:nvSpPr>
        <p:spPr>
          <a:xfrm>
            <a:off x="4980562" y="-10006"/>
            <a:ext cx="2974718" cy="2902495"/>
          </a:xfrm>
          <a:prstGeom prst="roundRect">
            <a:avLst>
              <a:gd name="adj" fmla="val 6269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3845A2B8-3786-4937-82D6-B42CEE84E2C6}"/>
              </a:ext>
            </a:extLst>
          </p:cNvPr>
          <p:cNvSpPr/>
          <p:nvPr/>
        </p:nvSpPr>
        <p:spPr>
          <a:xfrm>
            <a:off x="4980561" y="4978400"/>
            <a:ext cx="2974717" cy="1715008"/>
          </a:xfrm>
          <a:prstGeom prst="roundRect">
            <a:avLst>
              <a:gd name="adj" fmla="val 11562"/>
            </a:avLst>
          </a:prstGeom>
          <a:solidFill>
            <a:srgbClr val="FFC00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20681C-8E5A-4AD0-BFDF-A6C1B4815D3E}"/>
              </a:ext>
            </a:extLst>
          </p:cNvPr>
          <p:cNvSpPr txBox="1"/>
          <p:nvPr/>
        </p:nvSpPr>
        <p:spPr>
          <a:xfrm>
            <a:off x="7990620" y="1261193"/>
            <a:ext cx="1053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SD17B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25C2E4-0F53-409D-8941-C37F517BF75D}"/>
              </a:ext>
            </a:extLst>
          </p:cNvPr>
          <p:cNvSpPr txBox="1"/>
          <p:nvPr/>
        </p:nvSpPr>
        <p:spPr>
          <a:xfrm>
            <a:off x="7990620" y="5651238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SDHL</a:t>
            </a:r>
          </a:p>
        </p:txBody>
      </p:sp>
    </p:spTree>
    <p:extLst>
      <p:ext uri="{BB962C8B-B14F-4D97-AF65-F5344CB8AC3E}">
        <p14:creationId xmlns:p14="http://schemas.microsoft.com/office/powerpoint/2010/main" val="232213592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88F060E3-FA3A-442A-8D55-7B242FD1D5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7141" y="0"/>
            <a:ext cx="5937717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FCAEAD-A6BC-44EB-899B-A5EDBF47ECC8}"/>
              </a:ext>
            </a:extLst>
          </p:cNvPr>
          <p:cNvSpPr txBox="1"/>
          <p:nvPr/>
        </p:nvSpPr>
        <p:spPr>
          <a:xfrm>
            <a:off x="0" y="-10005"/>
            <a:ext cx="27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/>
              <a:t>EBP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073090EE-565C-469B-B041-47DEF8A3AEDF}"/>
              </a:ext>
            </a:extLst>
          </p:cNvPr>
          <p:cNvSpPr/>
          <p:nvPr/>
        </p:nvSpPr>
        <p:spPr>
          <a:xfrm>
            <a:off x="4887264" y="68092"/>
            <a:ext cx="4719192" cy="5828457"/>
          </a:xfrm>
          <a:prstGeom prst="roundRect">
            <a:avLst>
              <a:gd name="adj" fmla="val 3269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2434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9EB33E7-6B64-40F4-9DEA-A1FE0D833C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1081" y="268502"/>
            <a:ext cx="6436235" cy="64640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65E5488-1982-47CC-BA58-2CD6C6F46878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MGS</a:t>
            </a:r>
            <a:endParaRPr lang="en-HK" dirty="0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D9C76CF6-4C44-4E4E-BDE2-B95560CAFDC2}"/>
              </a:ext>
            </a:extLst>
          </p:cNvPr>
          <p:cNvSpPr/>
          <p:nvPr/>
        </p:nvSpPr>
        <p:spPr>
          <a:xfrm>
            <a:off x="4902957" y="268503"/>
            <a:ext cx="3654359" cy="5615462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89007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圆角矩形 4"/>
          <p:cNvSpPr/>
          <p:nvPr/>
        </p:nvSpPr>
        <p:spPr>
          <a:xfrm>
            <a:off x="4112986" y="0"/>
            <a:ext cx="4552496" cy="3293836"/>
          </a:xfrm>
          <a:prstGeom prst="round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86"/>
          </a:p>
        </p:txBody>
      </p:sp>
      <p:sp>
        <p:nvSpPr>
          <p:cNvPr id="3" name="圆角矩形 2"/>
          <p:cNvSpPr/>
          <p:nvPr/>
        </p:nvSpPr>
        <p:spPr>
          <a:xfrm>
            <a:off x="4103461" y="3332389"/>
            <a:ext cx="3503386" cy="343625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86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1896" y="0"/>
            <a:ext cx="3217636" cy="6858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6500132" y="4757057"/>
            <a:ext cx="837293" cy="29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6"/>
              <a:t>RXR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043511" y="1411515"/>
            <a:ext cx="837293" cy="29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6"/>
              <a:t>EcR</a:t>
            </a:r>
          </a:p>
        </p:txBody>
      </p:sp>
    </p:spTree>
    <p:custDataLst>
      <p:tags r:id="rId1"/>
    </p:custData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圆角矩形 6"/>
          <p:cNvSpPr/>
          <p:nvPr/>
        </p:nvSpPr>
        <p:spPr>
          <a:xfrm>
            <a:off x="4557940" y="4604204"/>
            <a:ext cx="3040289" cy="2002518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86"/>
          </a:p>
        </p:txBody>
      </p:sp>
      <p:sp>
        <p:nvSpPr>
          <p:cNvPr id="5" name="圆角矩形 4"/>
          <p:cNvSpPr/>
          <p:nvPr/>
        </p:nvSpPr>
        <p:spPr>
          <a:xfrm>
            <a:off x="4411890" y="0"/>
            <a:ext cx="3628118" cy="3490686"/>
          </a:xfrm>
          <a:prstGeom prst="round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86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2932" y="-10886"/>
            <a:ext cx="4059011" cy="686888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875236" y="1522640"/>
            <a:ext cx="837293" cy="29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6"/>
              <a:t>Nvd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6476093" y="5238297"/>
            <a:ext cx="940707" cy="29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6"/>
              <a:t>CYP18A1</a:t>
            </a: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CA5C6ED-D429-43D4-8697-92773C88D63C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MGR</a:t>
            </a:r>
            <a:endParaRPr lang="en-HK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713682A-FA42-44D0-9E6B-2FBA5132DF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2862" y="467616"/>
            <a:ext cx="7378557" cy="5922767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1A5FB2AA-4F94-4A7A-A412-4E17F5F83BB3}"/>
              </a:ext>
            </a:extLst>
          </p:cNvPr>
          <p:cNvSpPr/>
          <p:nvPr/>
        </p:nvSpPr>
        <p:spPr>
          <a:xfrm>
            <a:off x="4773749" y="467616"/>
            <a:ext cx="4747672" cy="5227506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4890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AD42108-20C0-42E9-8C0A-3EA16205A144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VK &amp; PMVK</a:t>
            </a:r>
            <a:endParaRPr lang="en-HK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10A6791-DF9E-422F-9D09-F90FFDFC26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0980" y="184666"/>
            <a:ext cx="6741753" cy="6488668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54EBCE78-8EF0-4354-B108-D09D77BE4AA6}"/>
              </a:ext>
            </a:extLst>
          </p:cNvPr>
          <p:cNvSpPr/>
          <p:nvPr/>
        </p:nvSpPr>
        <p:spPr>
          <a:xfrm>
            <a:off x="4124737" y="184666"/>
            <a:ext cx="4919874" cy="3306268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5402A99C-55EC-433B-800A-E1B2E96ECFE9}"/>
              </a:ext>
            </a:extLst>
          </p:cNvPr>
          <p:cNvSpPr/>
          <p:nvPr/>
        </p:nvSpPr>
        <p:spPr>
          <a:xfrm>
            <a:off x="4124739" y="3490934"/>
            <a:ext cx="4919870" cy="3009257"/>
          </a:xfrm>
          <a:prstGeom prst="roundRect">
            <a:avLst>
              <a:gd name="adj" fmla="val 5771"/>
            </a:avLst>
          </a:prstGeom>
          <a:solidFill>
            <a:srgbClr val="FFC00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B7E435-955C-4804-A04B-0D254C24372A}"/>
              </a:ext>
            </a:extLst>
          </p:cNvPr>
          <p:cNvSpPr txBox="1"/>
          <p:nvPr/>
        </p:nvSpPr>
        <p:spPr>
          <a:xfrm>
            <a:off x="9044609" y="4626230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V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E3FF3E-598D-4FA6-820B-C434429B3716}"/>
              </a:ext>
            </a:extLst>
          </p:cNvPr>
          <p:cNvSpPr txBox="1"/>
          <p:nvPr/>
        </p:nvSpPr>
        <p:spPr>
          <a:xfrm>
            <a:off x="9044609" y="1653134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MVK</a:t>
            </a:r>
          </a:p>
        </p:txBody>
      </p:sp>
    </p:spTree>
    <p:extLst>
      <p:ext uri="{BB962C8B-B14F-4D97-AF65-F5344CB8AC3E}">
        <p14:creationId xmlns:p14="http://schemas.microsoft.com/office/powerpoint/2010/main" val="1099915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7E2E702-32D8-4D6C-8981-334916F7AF3E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PMD</a:t>
            </a:r>
            <a:endParaRPr lang="en-HK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1ACDAD9-CE86-42DC-A994-5A6A8F11EF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9306" y="443980"/>
            <a:ext cx="5762613" cy="5984537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30AD3B16-B81C-4D1F-920B-BCDF06358D56}"/>
              </a:ext>
            </a:extLst>
          </p:cNvPr>
          <p:cNvSpPr/>
          <p:nvPr/>
        </p:nvSpPr>
        <p:spPr>
          <a:xfrm>
            <a:off x="4902958" y="429483"/>
            <a:ext cx="3952808" cy="5007221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7283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C9696A-F9BA-4D67-B6C4-0C707389A6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175" y="683223"/>
            <a:ext cx="7802612" cy="54915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5F629EE-D049-4F15-AD70-A76A5D547826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PI</a:t>
            </a:r>
            <a:endParaRPr lang="en-HK" dirty="0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EB108F90-085A-4DA1-B537-5561D61B304D}"/>
              </a:ext>
            </a:extLst>
          </p:cNvPr>
          <p:cNvSpPr/>
          <p:nvPr/>
        </p:nvSpPr>
        <p:spPr>
          <a:xfrm>
            <a:off x="3965711" y="683223"/>
            <a:ext cx="5923726" cy="4842933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35669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5114E51-BCD7-4923-A77E-7B1523993B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5199" y="657839"/>
            <a:ext cx="8741601" cy="55423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D6E67B1-0FF2-477E-AF6A-E95563B275CF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PPS</a:t>
            </a:r>
            <a:endParaRPr lang="en-HK" dirty="0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3C52C63C-3556-49E4-913A-4DC95655CB17}"/>
              </a:ext>
            </a:extLst>
          </p:cNvPr>
          <p:cNvSpPr/>
          <p:nvPr/>
        </p:nvSpPr>
        <p:spPr>
          <a:xfrm>
            <a:off x="3906075" y="637962"/>
            <a:ext cx="6758611" cy="4808682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92495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5BA1EF7-374D-4088-B566-2DA0ABB95E12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NTB</a:t>
            </a:r>
            <a:endParaRPr lang="en-HK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926066F-175A-4F24-976A-8A05820822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131" y="625860"/>
            <a:ext cx="8755534" cy="5606280"/>
          </a:xfrm>
          <a:prstGeom prst="rect">
            <a:avLst/>
          </a:prstGeom>
        </p:spPr>
      </p:pic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00D9236C-271C-42E2-B592-117893F0EEAA}"/>
              </a:ext>
            </a:extLst>
          </p:cNvPr>
          <p:cNvSpPr/>
          <p:nvPr/>
        </p:nvSpPr>
        <p:spPr>
          <a:xfrm>
            <a:off x="3965711" y="625860"/>
            <a:ext cx="5923726" cy="4842933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3179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7CD9702-EF60-4798-B40B-134F321CF4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9931" y="923909"/>
            <a:ext cx="8039588" cy="55039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D8BD109-8059-42DD-9656-275C92F3A27F}"/>
              </a:ext>
            </a:extLst>
          </p:cNvPr>
          <p:cNvSpPr txBox="1"/>
          <p:nvPr/>
        </p:nvSpPr>
        <p:spPr>
          <a:xfrm>
            <a:off x="0" y="0"/>
            <a:ext cx="1611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E24</a:t>
            </a:r>
            <a:endParaRPr lang="en-HK" dirty="0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F8D8B6E2-29D7-4FF4-98D6-0FAB549C9CCF}"/>
              </a:ext>
            </a:extLst>
          </p:cNvPr>
          <p:cNvSpPr/>
          <p:nvPr/>
        </p:nvSpPr>
        <p:spPr>
          <a:xfrm>
            <a:off x="2723322" y="683223"/>
            <a:ext cx="7454348" cy="5041716"/>
          </a:xfrm>
          <a:prstGeom prst="roundRect">
            <a:avLst>
              <a:gd name="adj" fmla="val 5826"/>
            </a:avLst>
          </a:prstGeom>
          <a:solidFill>
            <a:srgbClr val="00B0F0">
              <a:alpha val="1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06492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50</Words>
  <Application>Microsoft Office PowerPoint</Application>
  <PresentationFormat>Widescreen</PresentationFormat>
  <Paragraphs>34</Paragraphs>
  <Slides>2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ry</dc:creator>
  <cp:lastModifiedBy>Jerome Hui</cp:lastModifiedBy>
  <cp:revision>35</cp:revision>
  <dcterms:created xsi:type="dcterms:W3CDTF">2021-05-12T07:03:56Z</dcterms:created>
  <dcterms:modified xsi:type="dcterms:W3CDTF">2021-07-14T04:52:04Z</dcterms:modified>
</cp:coreProperties>
</file>